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68" r:id="rId2"/>
  </p:sldIdLst>
  <p:sldSz cx="12192000" cy="6858000"/>
  <p:notesSz cx="10018713" cy="68881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91" autoAdjust="0"/>
    <p:restoredTop sz="84329" autoAdjust="0"/>
  </p:normalViewPr>
  <p:slideViewPr>
    <p:cSldViewPr snapToGrid="0">
      <p:cViewPr varScale="1">
        <p:scale>
          <a:sx n="79" d="100"/>
          <a:sy n="79" d="100"/>
        </p:scale>
        <p:origin x="1164" y="9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41443" cy="345605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74952" y="0"/>
            <a:ext cx="4341443" cy="345605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r">
              <a:defRPr sz="1300"/>
            </a:lvl1pPr>
          </a:lstStyle>
          <a:p>
            <a:fld id="{A3051FB1-08C8-4FE2-9673-E68FBE66A595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941638" y="860425"/>
            <a:ext cx="4135437" cy="23256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06" tIns="48303" rIns="96606" bIns="48303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1001872" y="3314929"/>
            <a:ext cx="8014970" cy="2712214"/>
          </a:xfrm>
          <a:prstGeom prst="rect">
            <a:avLst/>
          </a:prstGeom>
        </p:spPr>
        <p:txBody>
          <a:bodyPr vert="horz" lIns="96606" tIns="48303" rIns="96606" bIns="48303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6542560"/>
            <a:ext cx="4341443" cy="345603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74952" y="6542560"/>
            <a:ext cx="4341443" cy="345603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r">
              <a:defRPr sz="1300"/>
            </a:lvl1pPr>
          </a:lstStyle>
          <a:p>
            <a:fld id="{2761BE55-E922-48E5-A404-D0C7756A5D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28879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761BE55-E922-48E5-A404-D0C7756A5D9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12256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4A6A3D-BB02-423E-A6C9-A402CBF6A1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F4684A4-B270-4B58-9BE3-2D8D820F84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648F27-CB9E-480B-9582-537D4D667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B92AB-0244-4ABE-AAA6-0EF56F032564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D90CCF0-669D-4D40-B0D6-A46E5CA411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7207B4-6859-4C2F-9AA1-E404DEABF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4367-77A6-4B9B-9D13-16ABC3AAF4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0650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BDD87D-E6E9-4516-A32A-C6D1241BC8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743B084-F9CB-4EAC-AB5C-06AA8B8836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C8F9A63-1014-48FF-9B60-1E8A3D8399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B92AB-0244-4ABE-AAA6-0EF56F032564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C38E85-F996-461E-965B-F9CF2E785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60ECC61-59B7-4269-B085-ADAFBB1CD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4367-77A6-4B9B-9D13-16ABC3AAF4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98079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24EEE7C-9C4D-45C7-B907-85E9C4FDBA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5792DFD-E21D-4217-BDE0-A0A0EDAD07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A5B0FC-1343-447E-B8D0-80F308CCDA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B92AB-0244-4ABE-AAA6-0EF56F032564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3EECE3-AF74-431E-83A4-B9AE70C82A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40F496C-595C-4C7A-BA24-DB6014FE68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4367-77A6-4B9B-9D13-16ABC3AAF4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2047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A9A203-BEF0-49F1-BE46-5E49434912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969C1D-BEAA-4F2E-9F6C-E9D76F3EA5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C6379E9-3572-44A3-B502-AE85E02753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B92AB-0244-4ABE-AAA6-0EF56F032564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F2A38FD-1245-43E5-9F3D-89B58AE616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C4A4516-F49F-417A-B61D-C374464EFE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4367-77A6-4B9B-9D13-16ABC3AAF4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3684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6F88D1-ED9A-401E-8607-4CB4773F5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FFC0526-E0A6-47E7-BEEE-9EBE3B9FD1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ADA4EC-75A8-47F7-9658-99A1CD46F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B92AB-0244-4ABE-AAA6-0EF56F032564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49A69FA-3832-4975-93A6-C6EB832AAA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F26D244-98E4-43A5-BA85-BFC20941C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4367-77A6-4B9B-9D13-16ABC3AAF4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6278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A52E91-51DD-4C30-A0E2-6E3B5AF5C0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348EE23-778E-4293-B34E-51926BC105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D9DA141-B6FB-4CE1-97FB-F10B4BCEDF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91EB988-02A3-43EA-9E67-C78401CFA3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B92AB-0244-4ABE-AAA6-0EF56F032564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43C9264-F9B7-4A3F-9806-A57ECE892D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1F609B5-7091-41C9-9977-630636E29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4367-77A6-4B9B-9D13-16ABC3AAF4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0055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2C6D1D2-5EB6-402A-8FF3-3F7CAF5397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C2A7346-A474-47E5-B38C-6814CF2E4F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FC3D536-9A2C-4587-A3E2-C1C4F8DEAA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0F9BF3E-909E-45BF-93AD-774DA80FFA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E46EB4B-43C4-4B69-BF7A-449D21BAFA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81DF724-8A01-4007-AE3C-CD88B51055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B92AB-0244-4ABE-AAA6-0EF56F032564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2021418-A0F7-4C72-A497-59959C436E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13F8197-3D64-48A4-B207-AD952413D2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4367-77A6-4B9B-9D13-16ABC3AAF4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7291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587108-0684-4A28-A29D-C4F32B308C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D078635-5816-478F-A070-4A591A44A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B92AB-0244-4ABE-AAA6-0EF56F032564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3D1950A-7361-4D81-8269-F554D50E0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2F3AD18-C9B0-4398-9677-C4A5BDA2CF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4367-77A6-4B9B-9D13-16ABC3AAF4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5487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CA13C9C-D3C4-4A30-A586-9E426FCC23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B92AB-0244-4ABE-AAA6-0EF56F032564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4AC2AA9-DACE-40FB-A2FE-2C54BE503D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CA77E59-5536-48AC-803D-AC7F84BC4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4367-77A6-4B9B-9D13-16ABC3AAF4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42024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5200E6-702A-42C3-ACF0-6E2B2135B8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EF161F5-745F-4996-AD0C-D1D1DDD137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FFC83B7-C2D3-49BE-ABAF-8AE617A3AA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FE18D41-55AD-418C-BD92-177A400B8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B92AB-0244-4ABE-AAA6-0EF56F032564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21F6ED7-16E4-4BC8-AB81-08EAFD133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F581326-9CED-4C13-B9CF-2443DEB453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4367-77A6-4B9B-9D13-16ABC3AAF4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1788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DC1806-2CBA-4A8B-B80A-B2BDB88166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FF9B12A-768F-425D-8E0D-CD8B2F1B29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E4C84A3-C488-439F-B17D-99DA89B013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915A8E2-6BC3-4587-A550-184CF7740F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B92AB-0244-4ABE-AAA6-0EF56F032564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43BDFCC-4D0D-4646-BC5E-B5409A543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DBDEEB8-09C7-46DA-B08C-024D7A7A9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14367-77A6-4B9B-9D13-16ABC3AAF4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9612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8CDEB65-EFF5-46C2-8347-D7EEC1DC98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84BBE45-F6DE-435F-AF46-3B3114BFB5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CFC3DE-D7E8-457D-A5D2-3EAB0C073F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3B92AB-0244-4ABE-AAA6-0EF56F032564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CC891F-4700-4D88-9851-5098B906F5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0D1217-9B29-4AD7-90AF-2DBF4465C9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14367-77A6-4B9B-9D13-16ABC3AAF4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172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C0842BBC-CAAC-4F55-9487-DEAC5C2387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83375" y="1219371"/>
            <a:ext cx="5172797" cy="243874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1D64BAE6-38F1-438B-A3E3-14ADE1AE61F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90677" y="979342"/>
            <a:ext cx="5001323" cy="3238952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5D1AB31-F996-4318-A0BB-6E19CCEB1C74}"/>
              </a:ext>
            </a:extLst>
          </p:cNvPr>
          <p:cNvSpPr txBox="1"/>
          <p:nvPr/>
        </p:nvSpPr>
        <p:spPr>
          <a:xfrm>
            <a:off x="490513" y="2073851"/>
            <a:ext cx="1298735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Meiryo UI" panose="020B0604030504040204" pitchFamily="50" charset="-128"/>
                <a:ea typeface="Meiryo UI" panose="020B0604030504040204" pitchFamily="50" charset="-128"/>
              </a:rPr>
              <a:t>Ethylene</a:t>
            </a:r>
          </a:p>
          <a:p>
            <a:r>
              <a:rPr lang="en-US" altLang="ja-JP" sz="1100" dirty="0">
                <a:latin typeface="Meiryo UI" panose="020B0604030504040204" pitchFamily="50" charset="-128"/>
                <a:ea typeface="Meiryo UI" panose="020B0604030504040204" pitchFamily="50" charset="-128"/>
              </a:rPr>
              <a:t>Acetate ester</a:t>
            </a:r>
          </a:p>
          <a:p>
            <a:r>
              <a:rPr kumimoji="1" lang="en-US" altLang="ja-JP" sz="1100" dirty="0">
                <a:latin typeface="Meiryo UI" panose="020B0604030504040204" pitchFamily="50" charset="-128"/>
                <a:ea typeface="Meiryo UI" panose="020B0604030504040204" pitchFamily="50" charset="-128"/>
              </a:rPr>
              <a:t>Methyl ester</a:t>
            </a:r>
          </a:p>
          <a:p>
            <a:r>
              <a:rPr lang="en-US" altLang="ja-JP" sz="1100" dirty="0">
                <a:latin typeface="Meiryo UI" panose="020B0604030504040204" pitchFamily="50" charset="-128"/>
                <a:ea typeface="Meiryo UI" panose="020B0604030504040204" pitchFamily="50" charset="-128"/>
              </a:rPr>
              <a:t>Methyl acetate</a:t>
            </a:r>
          </a:p>
          <a:p>
            <a:r>
              <a:rPr lang="en-US" altLang="ja-JP" sz="1100" dirty="0">
                <a:latin typeface="Meiryo UI" panose="020B0604030504040204" pitchFamily="50" charset="-128"/>
                <a:ea typeface="Meiryo UI" panose="020B0604030504040204" pitchFamily="50" charset="-128"/>
              </a:rPr>
              <a:t>Ethyl ester</a:t>
            </a:r>
          </a:p>
          <a:p>
            <a:r>
              <a:rPr kumimoji="1" lang="en-US" altLang="ja-JP" sz="1100" dirty="0">
                <a:latin typeface="Meiryo UI" panose="020B0604030504040204" pitchFamily="50" charset="-128"/>
                <a:ea typeface="Meiryo UI" panose="020B0604030504040204" pitchFamily="50" charset="-128"/>
              </a:rPr>
              <a:t>Ethyl acetate</a:t>
            </a:r>
          </a:p>
          <a:p>
            <a:r>
              <a:rPr kumimoji="1" lang="en-US" altLang="ja-JP" sz="1100" dirty="0">
                <a:latin typeface="Meiryo UI" panose="020B0604030504040204" pitchFamily="50" charset="-128"/>
                <a:ea typeface="Meiryo UI" panose="020B0604030504040204" pitchFamily="50" charset="-128"/>
              </a:rPr>
              <a:t>Alcohol</a:t>
            </a:r>
          </a:p>
          <a:p>
            <a:r>
              <a:rPr lang="en-US" altLang="ja-JP" sz="1100" dirty="0">
                <a:latin typeface="Meiryo UI" panose="020B0604030504040204" pitchFamily="50" charset="-128"/>
                <a:ea typeface="Meiryo UI" panose="020B0604030504040204" pitchFamily="50" charset="-128"/>
              </a:rPr>
              <a:t>Ethanol</a:t>
            </a:r>
          </a:p>
          <a:p>
            <a:r>
              <a:rPr kumimoji="1" lang="en-US" altLang="ja-JP" sz="1100" dirty="0">
                <a:latin typeface="Meiryo UI" panose="020B0604030504040204" pitchFamily="50" charset="-128"/>
                <a:ea typeface="Meiryo UI" panose="020B0604030504040204" pitchFamily="50" charset="-128"/>
              </a:rPr>
              <a:t>Methanol</a:t>
            </a:r>
          </a:p>
          <a:p>
            <a:r>
              <a:rPr lang="en-US" altLang="ja-JP" sz="1100" dirty="0">
                <a:latin typeface="Meiryo UI" panose="020B0604030504040204" pitchFamily="50" charset="-128"/>
                <a:ea typeface="Meiryo UI" panose="020B0604030504040204" pitchFamily="50" charset="-128"/>
              </a:rPr>
              <a:t>AAT</a:t>
            </a:r>
          </a:p>
          <a:p>
            <a:r>
              <a:rPr kumimoji="1" lang="en-US" altLang="ja-JP" sz="1100" dirty="0">
                <a:latin typeface="Meiryo UI" panose="020B0604030504040204" pitchFamily="50" charset="-128"/>
                <a:ea typeface="Meiryo UI" panose="020B0604030504040204" pitchFamily="50" charset="-128"/>
              </a:rPr>
              <a:t>ADH</a:t>
            </a:r>
          </a:p>
          <a:p>
            <a:r>
              <a:rPr lang="en-US" altLang="ja-JP" sz="1100" dirty="0">
                <a:latin typeface="Meiryo UI" panose="020B0604030504040204" pitchFamily="50" charset="-128"/>
                <a:ea typeface="Meiryo UI" panose="020B0604030504040204" pitchFamily="50" charset="-128"/>
              </a:rPr>
              <a:t>PDC</a:t>
            </a:r>
            <a:endParaRPr kumimoji="1" lang="ja-JP" altLang="en-US" sz="1100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441C089D-8C8F-4FD4-8F62-6942563943D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-759063" y="2954690"/>
            <a:ext cx="2201751" cy="283888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765B20B-EF04-4AB6-8A5A-32A7420E413A}"/>
              </a:ext>
            </a:extLst>
          </p:cNvPr>
          <p:cNvSpPr txBox="1"/>
          <p:nvPr/>
        </p:nvSpPr>
        <p:spPr>
          <a:xfrm>
            <a:off x="842481" y="5271919"/>
            <a:ext cx="1100764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Fig. S1</a:t>
            </a:r>
            <a:r>
              <a:rPr lang="en-US" altLang="ja-JP" sz="1400" dirty="0">
                <a:latin typeface="Meiryo UI" panose="020B0604030504040204" pitchFamily="50" charset="-128"/>
                <a:ea typeface="Meiryo UI" panose="020B0604030504040204" pitchFamily="50" charset="-128"/>
              </a:rPr>
              <a:t>. Co-expression network of straight chain volatiles (alcohols and esters)  and genes in ethanol pathway. A:’Orin ‘,  B:’Shinano Gold’. Cutoff lebel&lt;0.1.</a:t>
            </a:r>
          </a:p>
          <a:p>
            <a:r>
              <a:rPr lang="en-US" altLang="ja-JP" sz="1400" dirty="0">
                <a:latin typeface="Meiryo UI" panose="020B0604030504040204" pitchFamily="50" charset="-128"/>
                <a:ea typeface="Meiryo UI" panose="020B0604030504040204" pitchFamily="50" charset="-128"/>
              </a:rPr>
              <a:t>Submitted volatiles: ethylene, methyl acetate, methyl propanoate, methyl butanoate, ethyl acetate, ethyl propanoate, ethyl butanoate, ethyl hexanoate, butyl acetate, pentyl acetate, hexyl acetate, methanol, ethanol, butanol, pentanol, hexanol . </a:t>
            </a:r>
          </a:p>
          <a:p>
            <a:r>
              <a:rPr lang="en-US" altLang="ja-JP" sz="1400" dirty="0">
                <a:latin typeface="Meiryo UI" panose="020B0604030504040204" pitchFamily="50" charset="-128"/>
                <a:ea typeface="Meiryo UI" panose="020B0604030504040204" pitchFamily="50" charset="-128"/>
              </a:rPr>
              <a:t>Submitted genes: (PDC):MD04G1159900, </a:t>
            </a:r>
            <a:r>
              <a:rPr lang="en-US" altLang="ja-JP" sz="14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PDC1</a:t>
            </a:r>
            <a:r>
              <a:rPr lang="en-US" altLang="ja-JP" sz="1400" dirty="0">
                <a:latin typeface="Meiryo UI" panose="020B0604030504040204" pitchFamily="50" charset="-128"/>
                <a:ea typeface="Meiryo UI" panose="020B0604030504040204" pitchFamily="50" charset="-128"/>
              </a:rPr>
              <a:t>, </a:t>
            </a:r>
            <a:r>
              <a:rPr lang="en-US" altLang="ja-JP" sz="14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PDC2</a:t>
            </a:r>
            <a:r>
              <a:rPr lang="en-US" altLang="ja-JP" sz="1400" dirty="0">
                <a:latin typeface="Meiryo UI" panose="020B0604030504040204" pitchFamily="50" charset="-128"/>
                <a:ea typeface="Meiryo UI" panose="020B0604030504040204" pitchFamily="50" charset="-128"/>
              </a:rPr>
              <a:t>, MD12G1172400, (ADH):</a:t>
            </a:r>
            <a:r>
              <a:rPr lang="en-US" altLang="ja-JP" sz="14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DH1</a:t>
            </a:r>
            <a:r>
              <a:rPr lang="en-US" altLang="ja-JP" sz="1400" dirty="0">
                <a:latin typeface="Meiryo UI" panose="020B0604030504040204" pitchFamily="50" charset="-128"/>
                <a:ea typeface="Meiryo UI" panose="020B0604030504040204" pitchFamily="50" charset="-128"/>
              </a:rPr>
              <a:t>,</a:t>
            </a:r>
            <a:r>
              <a:rPr lang="en-US" altLang="ja-JP" sz="14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DH3-1,MdADH3-2</a:t>
            </a:r>
            <a:r>
              <a:rPr lang="en-US" altLang="ja-JP" sz="1400" dirty="0">
                <a:latin typeface="Meiryo UI" panose="020B0604030504040204" pitchFamily="50" charset="-128"/>
                <a:ea typeface="Meiryo UI" panose="020B0604030504040204" pitchFamily="50" charset="-128"/>
              </a:rPr>
              <a:t>, (AAT): MD02G1001400, </a:t>
            </a:r>
            <a:r>
              <a:rPr lang="en-US" altLang="ja-JP" sz="14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AT1-1</a:t>
            </a:r>
            <a:r>
              <a:rPr lang="en-US" altLang="ja-JP" sz="1400" dirty="0">
                <a:latin typeface="Meiryo UI" panose="020B0604030504040204" pitchFamily="50" charset="-128"/>
                <a:ea typeface="Meiryo UI" panose="020B0604030504040204" pitchFamily="50" charset="-128"/>
              </a:rPr>
              <a:t>,</a:t>
            </a:r>
            <a:r>
              <a:rPr lang="en-US" altLang="ja-JP" sz="14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AT1-2</a:t>
            </a:r>
            <a:r>
              <a:rPr lang="en-US" altLang="ja-JP" sz="1400" dirty="0">
                <a:latin typeface="Meiryo UI" panose="020B0604030504040204" pitchFamily="50" charset="-128"/>
                <a:ea typeface="Meiryo UI" panose="020B0604030504040204" pitchFamily="50" charset="-128"/>
              </a:rPr>
              <a:t>, </a:t>
            </a:r>
            <a:r>
              <a:rPr lang="en-US" altLang="ja-JP" sz="14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AT2</a:t>
            </a:r>
            <a:r>
              <a:rPr lang="en-US" altLang="ja-JP" sz="1400" dirty="0">
                <a:latin typeface="Meiryo UI" panose="020B0604030504040204" pitchFamily="50" charset="-128"/>
                <a:ea typeface="Meiryo UI" panose="020B0604030504040204" pitchFamily="50" charset="-128"/>
              </a:rPr>
              <a:t>, </a:t>
            </a:r>
            <a:r>
              <a:rPr lang="en-US" altLang="ja-JP" sz="14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AT6</a:t>
            </a:r>
            <a:r>
              <a:rPr lang="en-US" altLang="ja-JP" sz="1400" dirty="0">
                <a:latin typeface="Meiryo UI" panose="020B0604030504040204" pitchFamily="50" charset="-128"/>
                <a:ea typeface="Meiryo UI" panose="020B0604030504040204" pitchFamily="50" charset="-128"/>
              </a:rPr>
              <a:t>, (BAHD):MD02G1175500, MD13G11099000</a:t>
            </a:r>
            <a:endParaRPr kumimoji="1" lang="ja-JP" altLang="en-US" sz="1600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0904623-D9D5-485B-B4CD-3372C442F976}"/>
              </a:ext>
            </a:extLst>
          </p:cNvPr>
          <p:cNvSpPr txBox="1"/>
          <p:nvPr/>
        </p:nvSpPr>
        <p:spPr>
          <a:xfrm>
            <a:off x="10402753" y="3531153"/>
            <a:ext cx="119677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MD02G117550</a:t>
            </a:r>
            <a:endParaRPr kumimoji="1" lang="ja-JP" altLang="en-US" sz="10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F5AB3F1-B68D-437E-8E1D-60EAA7EC1F87}"/>
              </a:ext>
            </a:extLst>
          </p:cNvPr>
          <p:cNvSpPr txBox="1"/>
          <p:nvPr/>
        </p:nvSpPr>
        <p:spPr>
          <a:xfrm>
            <a:off x="9979800" y="3008722"/>
            <a:ext cx="119677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MD12G117240</a:t>
            </a:r>
            <a:endParaRPr kumimoji="1" lang="ja-JP" altLang="en-US" sz="10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20D2148-29D0-49CE-A57B-5F27D8FF0E2B}"/>
              </a:ext>
            </a:extLst>
          </p:cNvPr>
          <p:cNvSpPr txBox="1"/>
          <p:nvPr/>
        </p:nvSpPr>
        <p:spPr>
          <a:xfrm>
            <a:off x="9922025" y="2315630"/>
            <a:ext cx="795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PDC2</a:t>
            </a:r>
            <a:endParaRPr kumimoji="1" lang="ja-JP" altLang="en-US" sz="1000" b="1" i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AA38886-A596-47C1-BF50-F6D1C774E5C5}"/>
              </a:ext>
            </a:extLst>
          </p:cNvPr>
          <p:cNvSpPr txBox="1"/>
          <p:nvPr/>
        </p:nvSpPr>
        <p:spPr>
          <a:xfrm>
            <a:off x="8984199" y="2762501"/>
            <a:ext cx="766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AT2</a:t>
            </a:r>
            <a:endParaRPr kumimoji="1" lang="ja-JP" altLang="en-US" sz="1000" b="1" i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3F3529A-5070-4DDF-A851-872F7E570C05}"/>
              </a:ext>
            </a:extLst>
          </p:cNvPr>
          <p:cNvSpPr txBox="1"/>
          <p:nvPr/>
        </p:nvSpPr>
        <p:spPr>
          <a:xfrm>
            <a:off x="7965701" y="2889459"/>
            <a:ext cx="998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AT1-1</a:t>
            </a:r>
            <a:endParaRPr kumimoji="1" lang="ja-JP" altLang="en-US" sz="1000" b="1" i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5F734DE-0F67-4026-B9F5-2D715B9C597E}"/>
              </a:ext>
            </a:extLst>
          </p:cNvPr>
          <p:cNvSpPr txBox="1"/>
          <p:nvPr/>
        </p:nvSpPr>
        <p:spPr>
          <a:xfrm>
            <a:off x="9404081" y="3262638"/>
            <a:ext cx="998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AT1-2</a:t>
            </a:r>
            <a:endParaRPr kumimoji="1" lang="ja-JP" altLang="en-US" sz="1000" b="1" i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481C8A5-6600-4C7D-85B8-6EB7BAEE2C5A}"/>
              </a:ext>
            </a:extLst>
          </p:cNvPr>
          <p:cNvSpPr txBox="1"/>
          <p:nvPr/>
        </p:nvSpPr>
        <p:spPr>
          <a:xfrm>
            <a:off x="8092993" y="3466307"/>
            <a:ext cx="1311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MD02G1001400</a:t>
            </a:r>
            <a:endParaRPr kumimoji="1" lang="ja-JP" altLang="en-US" sz="10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BEF6192-A0AA-4361-8F5C-66B7CA255218}"/>
              </a:ext>
            </a:extLst>
          </p:cNvPr>
          <p:cNvSpPr txBox="1"/>
          <p:nvPr/>
        </p:nvSpPr>
        <p:spPr>
          <a:xfrm>
            <a:off x="8437870" y="1533685"/>
            <a:ext cx="998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DH3</a:t>
            </a:r>
            <a:endParaRPr kumimoji="1" lang="ja-JP" altLang="en-US" sz="1000" b="1" i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F967475-9315-422B-9BF7-48BE53DEF42F}"/>
              </a:ext>
            </a:extLst>
          </p:cNvPr>
          <p:cNvSpPr txBox="1"/>
          <p:nvPr/>
        </p:nvSpPr>
        <p:spPr>
          <a:xfrm>
            <a:off x="7960012" y="2152648"/>
            <a:ext cx="9986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DH3-</a:t>
            </a:r>
            <a:r>
              <a:rPr lang="en-US" altLang="ja-JP" sz="10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like</a:t>
            </a:r>
            <a:endParaRPr kumimoji="1" lang="ja-JP" altLang="en-US" sz="1000" b="1" i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F988C80-BB68-4389-A6D0-CEED42BF4612}"/>
              </a:ext>
            </a:extLst>
          </p:cNvPr>
          <p:cNvSpPr txBox="1"/>
          <p:nvPr/>
        </p:nvSpPr>
        <p:spPr>
          <a:xfrm>
            <a:off x="7225382" y="2956045"/>
            <a:ext cx="998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DH1</a:t>
            </a:r>
            <a:endParaRPr kumimoji="1" lang="ja-JP" altLang="en-US" sz="1000" b="1" i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B8989F6-8FC7-447F-8DD4-AE5758EEDEC6}"/>
              </a:ext>
            </a:extLst>
          </p:cNvPr>
          <p:cNvSpPr txBox="1"/>
          <p:nvPr/>
        </p:nvSpPr>
        <p:spPr>
          <a:xfrm>
            <a:off x="8780182" y="2185279"/>
            <a:ext cx="13809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MD04G1159900</a:t>
            </a:r>
            <a:endParaRPr kumimoji="1" lang="ja-JP" altLang="en-US" sz="10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2DE7456-0665-4071-A83A-1612E1874E54}"/>
              </a:ext>
            </a:extLst>
          </p:cNvPr>
          <p:cNvSpPr txBox="1"/>
          <p:nvPr/>
        </p:nvSpPr>
        <p:spPr>
          <a:xfrm>
            <a:off x="2620889" y="1547670"/>
            <a:ext cx="9986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DH3-like</a:t>
            </a:r>
            <a:endParaRPr kumimoji="1" lang="ja-JP" altLang="en-US" sz="1000" b="1" i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E8D2515-6961-4470-A38B-C87019CDE1F8}"/>
              </a:ext>
            </a:extLst>
          </p:cNvPr>
          <p:cNvSpPr txBox="1"/>
          <p:nvPr/>
        </p:nvSpPr>
        <p:spPr>
          <a:xfrm>
            <a:off x="3211353" y="1315682"/>
            <a:ext cx="998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DH3</a:t>
            </a:r>
            <a:endParaRPr kumimoji="1" lang="ja-JP" altLang="en-US" sz="1000" b="1" i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B2C75C6-0FC5-4F82-85C3-3641F6C88986}"/>
              </a:ext>
            </a:extLst>
          </p:cNvPr>
          <p:cNvSpPr txBox="1"/>
          <p:nvPr/>
        </p:nvSpPr>
        <p:spPr>
          <a:xfrm>
            <a:off x="2956754" y="3166385"/>
            <a:ext cx="13809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MD04G1159900</a:t>
            </a:r>
            <a:endParaRPr kumimoji="1" lang="ja-JP" altLang="en-US" sz="10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631EBC0-3D4E-4073-9024-D6234372B2B2}"/>
              </a:ext>
            </a:extLst>
          </p:cNvPr>
          <p:cNvSpPr txBox="1"/>
          <p:nvPr/>
        </p:nvSpPr>
        <p:spPr>
          <a:xfrm>
            <a:off x="3458196" y="2008952"/>
            <a:ext cx="766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PDC2</a:t>
            </a:r>
            <a:endParaRPr kumimoji="1" lang="ja-JP" altLang="en-US" sz="1000" b="1" i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D3778C4-8942-4DAC-BF15-AEC61B1999AC}"/>
              </a:ext>
            </a:extLst>
          </p:cNvPr>
          <p:cNvSpPr txBox="1"/>
          <p:nvPr/>
        </p:nvSpPr>
        <p:spPr>
          <a:xfrm>
            <a:off x="5898424" y="2457087"/>
            <a:ext cx="13809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MD13G1109000</a:t>
            </a:r>
            <a:endParaRPr kumimoji="1" lang="ja-JP" altLang="en-US" sz="10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B6FAAF84-1091-4CD2-9A42-25ECB8798DD6}"/>
              </a:ext>
            </a:extLst>
          </p:cNvPr>
          <p:cNvSpPr txBox="1"/>
          <p:nvPr/>
        </p:nvSpPr>
        <p:spPr>
          <a:xfrm>
            <a:off x="4375646" y="2584273"/>
            <a:ext cx="998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DH1</a:t>
            </a:r>
            <a:endParaRPr kumimoji="1" lang="ja-JP" altLang="en-US" sz="1000" b="1" i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C9FC2CC9-6C47-45BA-86BC-EC017D8C0293}"/>
              </a:ext>
            </a:extLst>
          </p:cNvPr>
          <p:cNvSpPr txBox="1"/>
          <p:nvPr/>
        </p:nvSpPr>
        <p:spPr>
          <a:xfrm>
            <a:off x="4375646" y="1739648"/>
            <a:ext cx="998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MdAAT1-2</a:t>
            </a:r>
            <a:endParaRPr kumimoji="1" lang="ja-JP" altLang="en-US" sz="1000" b="1" i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50843697-80B1-46EE-A474-206C6D5429E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3646" t="1" r="12174" b="27431"/>
          <a:stretch/>
        </p:blipFill>
        <p:spPr>
          <a:xfrm>
            <a:off x="236086" y="3647511"/>
            <a:ext cx="138267" cy="16974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FAFA991D-AC1C-4E0C-A59D-DAD16BC3451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5030" b="8240"/>
          <a:stretch/>
        </p:blipFill>
        <p:spPr>
          <a:xfrm>
            <a:off x="236086" y="3131117"/>
            <a:ext cx="173646" cy="182164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FEED366-D34D-4FB6-B666-6E2D362B953C}"/>
              </a:ext>
            </a:extLst>
          </p:cNvPr>
          <p:cNvSpPr txBox="1"/>
          <p:nvPr/>
        </p:nvSpPr>
        <p:spPr>
          <a:xfrm>
            <a:off x="2082103" y="829918"/>
            <a:ext cx="1605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Meiryo UI" panose="020B0604030504040204" pitchFamily="50" charset="-128"/>
                <a:ea typeface="Meiryo UI" panose="020B0604030504040204" pitchFamily="50" charset="-128"/>
              </a:rPr>
              <a:t>A:Orin</a:t>
            </a:r>
            <a:endParaRPr kumimoji="1" lang="ja-JP" altLang="en-US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09AC999-31BC-4FCB-8ECB-C2107D19E743}"/>
              </a:ext>
            </a:extLst>
          </p:cNvPr>
          <p:cNvSpPr txBox="1"/>
          <p:nvPr/>
        </p:nvSpPr>
        <p:spPr>
          <a:xfrm>
            <a:off x="7702039" y="837885"/>
            <a:ext cx="2692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Meiryo UI" panose="020B0604030504040204" pitchFamily="50" charset="-128"/>
                <a:ea typeface="Meiryo UI" panose="020B0604030504040204" pitchFamily="50" charset="-128"/>
              </a:rPr>
              <a:t>B:Shinano Gold</a:t>
            </a:r>
            <a:endParaRPr kumimoji="1" lang="ja-JP" altLang="en-US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pic>
        <p:nvPicPr>
          <p:cNvPr id="38" name="図 37">
            <a:extLst>
              <a:ext uri="{FF2B5EF4-FFF2-40B4-BE49-F238E27FC236}">
                <a16:creationId xmlns:a16="http://schemas.microsoft.com/office/drawing/2014/main" id="{EF05279A-BE48-44E1-8AB8-406A7BCAD5F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54415" b="694"/>
          <a:stretch/>
        </p:blipFill>
        <p:spPr>
          <a:xfrm>
            <a:off x="0" y="1555603"/>
            <a:ext cx="1684962" cy="368035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21B38510-9840-4B74-99AA-248144D4C42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3554" t="27937" r="-11065" b="31169"/>
          <a:stretch/>
        </p:blipFill>
        <p:spPr>
          <a:xfrm>
            <a:off x="137945" y="1803505"/>
            <a:ext cx="2076425" cy="1480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2327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502</TotalTime>
  <Words>165</Words>
  <Application>Microsoft Office PowerPoint</Application>
  <PresentationFormat>ワイド画面</PresentationFormat>
  <Paragraphs>3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Meiryo UI</vt:lpstr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中　福代</dc:creator>
  <cp:lastModifiedBy>田中　福代</cp:lastModifiedBy>
  <cp:revision>15</cp:revision>
  <cp:lastPrinted>2025-04-07T09:47:40Z</cp:lastPrinted>
  <dcterms:created xsi:type="dcterms:W3CDTF">2025-02-15T06:23:54Z</dcterms:created>
  <dcterms:modified xsi:type="dcterms:W3CDTF">2025-08-06T09:30:27Z</dcterms:modified>
</cp:coreProperties>
</file>